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63C7D3-CD47-4591-9DFE-62EA61F8B0A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DC9FF5-8F95-42C3-9E83-79AAB3B2673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D8ED1A-F81C-4D45-8D0F-105AC0752A4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3D17A2-4428-48C7-9809-C602A271CC2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BCBCED-FC83-4FE6-9133-78F3F4AE9BB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BE9793-E942-4A45-9865-BCA72F4FDC6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766185-2F36-45AD-82A0-F71FC0EF86D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501B55-38BB-4936-87AC-4DAB94EE9A3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04E3F8-0829-4B9E-917C-210B53E9A06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3E0C0A-BD9A-4FE7-9B87-30B24C79D2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1B5B42-F517-4BB5-814B-2CD2B2D2580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A8FE8D-4AC7-4D6C-A8A7-5E0389A574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E249993-741B-4947-A659-31470CADBA9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4"/>
          <p:cNvSpPr/>
          <p:nvPr/>
        </p:nvSpPr>
        <p:spPr>
          <a:xfrm>
            <a:off x="838080" y="4876920"/>
            <a:ext cx="1447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crambl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5"/>
          <p:cNvSpPr/>
          <p:nvPr/>
        </p:nvSpPr>
        <p:spPr>
          <a:xfrm>
            <a:off x="3581280" y="4876920"/>
            <a:ext cx="2057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iCR593775-1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6"/>
          <p:cNvSpPr/>
          <p:nvPr/>
        </p:nvSpPr>
        <p:spPr>
          <a:xfrm>
            <a:off x="6400800" y="4876920"/>
            <a:ext cx="2057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iCR593775-1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7"/>
          <p:cNvSpPr/>
          <p:nvPr/>
        </p:nvSpPr>
        <p:spPr>
          <a:xfrm>
            <a:off x="304920" y="304920"/>
            <a:ext cx="8839080" cy="19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Arial"/>
              </a:rPr>
              <a:t>The triple negative breast cancer MDA-MB-231 cell lines has no receptors for oestrogen, yet responds to  siRNA against CR593775</a:t>
            </a: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Arial"/>
              </a:rPr>
              <a:t>(crystal violet cell proliferation assay)</a:t>
            </a:r>
            <a:endParaRPr b="0" lang="en-US" sz="3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" name="Picture 8" descr="scr-2-E2"/>
          <p:cNvPicPr/>
          <p:nvPr/>
        </p:nvPicPr>
        <p:blipFill>
          <a:blip r:embed="rId1"/>
          <a:stretch/>
        </p:blipFill>
        <p:spPr>
          <a:xfrm>
            <a:off x="0" y="2362320"/>
            <a:ext cx="2971800" cy="222876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9" descr="14-2-1-E2"/>
          <p:cNvPicPr/>
          <p:nvPr/>
        </p:nvPicPr>
        <p:blipFill>
          <a:blip r:embed="rId2"/>
          <a:stretch/>
        </p:blipFill>
        <p:spPr>
          <a:xfrm>
            <a:off x="3048120" y="2362320"/>
            <a:ext cx="2971800" cy="222876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10" descr="15-2-1-E2"/>
          <p:cNvPicPr/>
          <p:nvPr/>
        </p:nvPicPr>
        <p:blipFill>
          <a:blip r:embed="rId3"/>
          <a:stretch/>
        </p:blipFill>
        <p:spPr>
          <a:xfrm>
            <a:off x="6075360" y="2362320"/>
            <a:ext cx="2946240" cy="2209680"/>
          </a:xfrm>
          <a:prstGeom prst="rect">
            <a:avLst/>
          </a:prstGeom>
          <a:ln w="0">
            <a:noFill/>
          </a:ln>
        </p:spPr>
      </p:pic>
      <p:sp>
        <p:nvSpPr>
          <p:cNvPr id="48" name="TextBox 10"/>
          <p:cNvSpPr/>
          <p:nvPr/>
        </p:nvSpPr>
        <p:spPr>
          <a:xfrm>
            <a:off x="3132720" y="6172200"/>
            <a:ext cx="3402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Lin et al., Supplementary Fig.1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5-17T16:15:06Z</dcterms:created>
  <dc:creator>Karmanos Cancer Institute</dc:creator>
  <dc:description/>
  <dc:language>en-US</dc:language>
  <cp:lastModifiedBy>Erica</cp:lastModifiedBy>
  <dcterms:modified xsi:type="dcterms:W3CDTF">2016-11-20T06:29:47Z</dcterms:modified>
  <cp:revision>6</cp:revision>
  <dc:subject/>
  <dc:title>Slide 1</dc:title>
</cp:coreProperties>
</file>